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_rels/presentation.xml.rels" ContentType="application/vnd.openxmlformats-package.relationships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tif" ContentType="image/tiff"/>
  <Override PartName="/ppt/media/image9.png" ContentType="image/png"/>
  <Override PartName="/ppt/media/image6.jpeg" ContentType="image/jpeg"/>
  <Override PartName="/ppt/media/image8.png" ContentType="image/png"/>
  <Override PartName="/ppt/media/image7.png" ContentType="image/png"/>
  <Override PartName="/ppt/media/image10.png" ContentType="image/png"/>
  <Override PartName="/ppt/slideLayouts/_rels/slideLayout52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53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</p:sld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  <p:sldId id="264" r:id="rId15"/>
    <p:sldId id="265" r:id="rId16"/>
    <p:sldId id="266" r:id="rId17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" Target="slides/slide1.xml"/><Relationship Id="rId8" Type="http://schemas.openxmlformats.org/officeDocument/2006/relationships/slide" Target="slides/slide2.xml"/><Relationship Id="rId9" Type="http://schemas.openxmlformats.org/officeDocument/2006/relationships/slide" Target="slides/slide3.xml"/><Relationship Id="rId10" Type="http://schemas.openxmlformats.org/officeDocument/2006/relationships/slide" Target="slides/slide4.xml"/><Relationship Id="rId11" Type="http://schemas.openxmlformats.org/officeDocument/2006/relationships/slide" Target="slides/slide5.xml"/><Relationship Id="rId12" Type="http://schemas.openxmlformats.org/officeDocument/2006/relationships/slide" Target="slides/slide6.xml"/><Relationship Id="rId13" Type="http://schemas.openxmlformats.org/officeDocument/2006/relationships/slide" Target="slides/slide7.xml"/><Relationship Id="rId14" Type="http://schemas.openxmlformats.org/officeDocument/2006/relationships/slide" Target="slides/slide8.xml"/><Relationship Id="rId15" Type="http://schemas.openxmlformats.org/officeDocument/2006/relationships/slide" Target="slides/slide9.xml"/><Relationship Id="rId16" Type="http://schemas.openxmlformats.org/officeDocument/2006/relationships/slide" Target="slides/slide10.xml"/><Relationship Id="rId17" Type="http://schemas.openxmlformats.org/officeDocument/2006/relationships/slide" Target="slides/slide11.xml"/><Relationship Id="rId1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F23AF-18BB-4441-946F-79FA5092EA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6F8C1-D3F3-44AF-9603-724CCB70B3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156E5-0DA0-41D5-92E0-39C0FFD3B1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/>
          </p:nvPr>
        </p:nvSpPr>
        <p:spPr>
          <a:xfrm>
            <a:off x="446760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2" name="PlaceHolder 4"/>
          <p:cNvSpPr>
            <a:spLocks noGrp="1"/>
          </p:cNvSpPr>
          <p:nvPr>
            <p:ph/>
          </p:nvPr>
        </p:nvSpPr>
        <p:spPr>
          <a:xfrm>
            <a:off x="786852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3" name="PlaceHolder 5"/>
          <p:cNvSpPr>
            <a:spLocks noGrp="1"/>
          </p:cNvSpPr>
          <p:nvPr>
            <p:ph/>
          </p:nvPr>
        </p:nvSpPr>
        <p:spPr>
          <a:xfrm>
            <a:off x="106668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4" name="PlaceHolder 6"/>
          <p:cNvSpPr>
            <a:spLocks noGrp="1"/>
          </p:cNvSpPr>
          <p:nvPr>
            <p:ph/>
          </p:nvPr>
        </p:nvSpPr>
        <p:spPr>
          <a:xfrm>
            <a:off x="446760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5" name="PlaceHolder 7"/>
          <p:cNvSpPr>
            <a:spLocks noGrp="1"/>
          </p:cNvSpPr>
          <p:nvPr>
            <p:ph/>
          </p:nvPr>
        </p:nvSpPr>
        <p:spPr>
          <a:xfrm>
            <a:off x="786852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2545F3-8999-40A3-9E5C-1B8144337D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0287A0C-2CAB-4BE1-A5A3-1EE3171C0D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subTitle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A9E7720-540E-4B2C-BECD-B43C71F612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80A9619-D16B-4114-9129-49623F5E37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C60486E-7BCE-4F3A-82E5-D955B93C92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52A9109-3C77-49C9-A794-F853ADD142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subTitle"/>
          </p:nvPr>
        </p:nvSpPr>
        <p:spPr>
          <a:xfrm>
            <a:off x="1066680" y="642960"/>
            <a:ext cx="100584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EBA8935-7F4B-4251-9903-3C988C23A2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5CFBE5-BDA1-46C9-BD66-CD7631A905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 type="subTitle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DBF0B0-7886-4CD9-AEB7-BC7D863816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9ADF916-57EF-4FBB-B918-6073BA1A1B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8747DCA-8BD5-4027-BB50-FA9524287F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0296FB3-A608-4D27-ABB8-DD8DED358E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8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9" name="PlaceHolder 5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A9F52C9-D559-48C4-B6DA-507340BABE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/>
          </p:nvPr>
        </p:nvSpPr>
        <p:spPr>
          <a:xfrm>
            <a:off x="446760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/>
          </p:nvPr>
        </p:nvSpPr>
        <p:spPr>
          <a:xfrm>
            <a:off x="786852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4" name="PlaceHolder 5"/>
          <p:cNvSpPr>
            <a:spLocks noGrp="1"/>
          </p:cNvSpPr>
          <p:nvPr>
            <p:ph/>
          </p:nvPr>
        </p:nvSpPr>
        <p:spPr>
          <a:xfrm>
            <a:off x="106668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5" name="PlaceHolder 6"/>
          <p:cNvSpPr>
            <a:spLocks noGrp="1"/>
          </p:cNvSpPr>
          <p:nvPr>
            <p:ph/>
          </p:nvPr>
        </p:nvSpPr>
        <p:spPr>
          <a:xfrm>
            <a:off x="446760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6" name="PlaceHolder 7"/>
          <p:cNvSpPr>
            <a:spLocks noGrp="1"/>
          </p:cNvSpPr>
          <p:nvPr>
            <p:ph/>
          </p:nvPr>
        </p:nvSpPr>
        <p:spPr>
          <a:xfrm>
            <a:off x="786852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4C5460A-052C-417D-8170-E51CBE3F97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5591E42-0298-40BF-8275-00C4282B12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 type="subTitle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AA963D5-1951-4990-ABCD-553B1184FF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DF2C494-37AF-43C3-938C-691B6B77BA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16B94E9-1140-486E-B28A-745877CD8E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1F76D62-1B7C-48C6-8F19-8988F0A9DD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B4604-63E6-4CB4-9868-7634CCA8DC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subTitle"/>
          </p:nvPr>
        </p:nvSpPr>
        <p:spPr>
          <a:xfrm>
            <a:off x="1066680" y="642960"/>
            <a:ext cx="100584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166A072-07DE-43EE-B9FA-C50C815913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22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3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4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7C08263-3096-4A0E-B28E-AB3B50B575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26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7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8" name="PlaceHolder 4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4A30542-7345-4D8A-9D33-3BF09D8D5B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30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31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32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6DFFEA8-1CA8-4679-AF40-9B0AD0BC8F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35" name="PlaceHolder 3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F75E687-FE41-4C55-9350-50D37AD989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38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39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0" name="PlaceHolder 5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B93D659-3810-40C5-9D7C-5DE7804EA7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46760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786852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5" name="PlaceHolder 5"/>
          <p:cNvSpPr>
            <a:spLocks noGrp="1"/>
          </p:cNvSpPr>
          <p:nvPr>
            <p:ph/>
          </p:nvPr>
        </p:nvSpPr>
        <p:spPr>
          <a:xfrm>
            <a:off x="106668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6" name="PlaceHolder 6"/>
          <p:cNvSpPr>
            <a:spLocks noGrp="1"/>
          </p:cNvSpPr>
          <p:nvPr>
            <p:ph/>
          </p:nvPr>
        </p:nvSpPr>
        <p:spPr>
          <a:xfrm>
            <a:off x="446760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7" name="PlaceHolder 7"/>
          <p:cNvSpPr>
            <a:spLocks noGrp="1"/>
          </p:cNvSpPr>
          <p:nvPr>
            <p:ph/>
          </p:nvPr>
        </p:nvSpPr>
        <p:spPr>
          <a:xfrm>
            <a:off x="786852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728682E-924E-4FBE-8900-ED603D3699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A0D5204-67A4-4FFB-9BCD-AE8CEC4D27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 type="subTitle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AE1B99D-0C0F-4DFD-9831-9AB52F8254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52431C9-23E4-48FA-8639-2E4B3F2A10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90C91-1710-4A3B-9C8F-D91E65857D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5055884-3C53-4C93-89A6-CA5AA44C20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5F4E7BA-42C2-4DE1-A287-4DFBE93442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subTitle"/>
          </p:nvPr>
        </p:nvSpPr>
        <p:spPr>
          <a:xfrm>
            <a:off x="1066680" y="642960"/>
            <a:ext cx="100584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6D2A80F-0101-4B48-878D-8DA57DED8A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477C6D1-01B6-408E-AFCB-20ED742F62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69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0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1" name="PlaceHolder 4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CA6C38C-72F8-412C-91DA-CABCD09E43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4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5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19AE918-2290-4E01-A224-6DA7594A39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8" name="PlaceHolder 3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319CD42-6124-41D9-A54A-92796B37C2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80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81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82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83" name="PlaceHolder 5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368171D-5026-4F32-9E94-8F7AF2CD62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86" name="PlaceHolder 3"/>
          <p:cNvSpPr>
            <a:spLocks noGrp="1"/>
          </p:cNvSpPr>
          <p:nvPr>
            <p:ph/>
          </p:nvPr>
        </p:nvSpPr>
        <p:spPr>
          <a:xfrm>
            <a:off x="446760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87" name="PlaceHolder 4"/>
          <p:cNvSpPr>
            <a:spLocks noGrp="1"/>
          </p:cNvSpPr>
          <p:nvPr>
            <p:ph/>
          </p:nvPr>
        </p:nvSpPr>
        <p:spPr>
          <a:xfrm>
            <a:off x="786852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88" name="PlaceHolder 5"/>
          <p:cNvSpPr>
            <a:spLocks noGrp="1"/>
          </p:cNvSpPr>
          <p:nvPr>
            <p:ph/>
          </p:nvPr>
        </p:nvSpPr>
        <p:spPr>
          <a:xfrm>
            <a:off x="106668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89" name="PlaceHolder 6"/>
          <p:cNvSpPr>
            <a:spLocks noGrp="1"/>
          </p:cNvSpPr>
          <p:nvPr>
            <p:ph/>
          </p:nvPr>
        </p:nvSpPr>
        <p:spPr>
          <a:xfrm>
            <a:off x="446760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0" name="PlaceHolder 7"/>
          <p:cNvSpPr>
            <a:spLocks noGrp="1"/>
          </p:cNvSpPr>
          <p:nvPr>
            <p:ph/>
          </p:nvPr>
        </p:nvSpPr>
        <p:spPr>
          <a:xfrm>
            <a:off x="786852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E090827-ECE9-4EE2-9D03-47C62DED50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E85AA70-82DF-493F-B87F-928B69D807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A97E7-AFF7-47BA-BDC3-3254E09A89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 type="subTitle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65FE704-134B-4883-833E-874228D16D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01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09AFC9A-AADE-44EB-A728-DE974E6846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03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04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F3834C5-443D-4AB5-B7A5-4296A44ED2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B2B5A12-D04F-4570-AC89-305C61201A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subTitle"/>
          </p:nvPr>
        </p:nvSpPr>
        <p:spPr>
          <a:xfrm>
            <a:off x="1066680" y="642960"/>
            <a:ext cx="100584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9E9D36E-9D36-488D-95A0-B0DF1C4B72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08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09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0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508A197-BAAE-4685-A857-22DE866844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AAE89A5-60E9-4D58-9C99-81B2782110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16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7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8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3A46F2C-71D3-4787-86DB-339EF5919D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5BB447C-9730-4840-BA84-D31C967394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23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24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25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26" name="PlaceHolder 5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2700C27-1D44-41A1-9753-22634E0885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subTitle"/>
          </p:nvPr>
        </p:nvSpPr>
        <p:spPr>
          <a:xfrm>
            <a:off x="1066680" y="642960"/>
            <a:ext cx="100584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ED3B8-0330-4FD2-809B-0D1D7F3BA7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446760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7868520" y="210312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31" name="PlaceHolder 5"/>
          <p:cNvSpPr>
            <a:spLocks noGrp="1"/>
          </p:cNvSpPr>
          <p:nvPr>
            <p:ph/>
          </p:nvPr>
        </p:nvSpPr>
        <p:spPr>
          <a:xfrm>
            <a:off x="106668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32" name="PlaceHolder 6"/>
          <p:cNvSpPr>
            <a:spLocks noGrp="1"/>
          </p:cNvSpPr>
          <p:nvPr>
            <p:ph/>
          </p:nvPr>
        </p:nvSpPr>
        <p:spPr>
          <a:xfrm>
            <a:off x="446760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33" name="PlaceHolder 7"/>
          <p:cNvSpPr>
            <a:spLocks noGrp="1"/>
          </p:cNvSpPr>
          <p:nvPr>
            <p:ph/>
          </p:nvPr>
        </p:nvSpPr>
        <p:spPr>
          <a:xfrm>
            <a:off x="7868520" y="4114080"/>
            <a:ext cx="323856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40F04EE-E709-4F68-A608-3959DB3DD7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6E4BE-38E6-4DCA-9B1D-656F0C6EBF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6220800" y="411408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67231D-D492-4EA8-90D0-454DCF493F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106668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6220800" y="2103120"/>
            <a:ext cx="490824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1066680" y="4114080"/>
            <a:ext cx="10058400" cy="183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DAAA0-D842-4B47-A21D-462360218C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5.xml"/><Relationship Id="rId4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7.xml"/><Relationship Id="rId6" Type="http://schemas.openxmlformats.org/officeDocument/2006/relationships/slideLayout" Target="../slideLayouts/slideLayout28.xml"/><Relationship Id="rId7" Type="http://schemas.openxmlformats.org/officeDocument/2006/relationships/slideLayout" Target="../slideLayouts/slideLayout29.xml"/><Relationship Id="rId8" Type="http://schemas.openxmlformats.org/officeDocument/2006/relationships/slideLayout" Target="../slideLayouts/slideLayout30.xml"/><Relationship Id="rId9" Type="http://schemas.openxmlformats.org/officeDocument/2006/relationships/slideLayout" Target="../slideLayouts/slideLayout31.xml"/><Relationship Id="rId10" Type="http://schemas.openxmlformats.org/officeDocument/2006/relationships/slideLayout" Target="../slideLayouts/slideLayout32.xml"/><Relationship Id="rId11" Type="http://schemas.openxmlformats.org/officeDocument/2006/relationships/slideLayout" Target="../slideLayouts/slideLayout33.xml"/><Relationship Id="rId12" Type="http://schemas.openxmlformats.org/officeDocument/2006/relationships/slideLayout" Target="../slideLayouts/slideLayout34.xml"/><Relationship Id="rId13" Type="http://schemas.openxmlformats.org/officeDocument/2006/relationships/slideLayout" Target="../slideLayouts/slideLayout35.xml"/><Relationship Id="rId14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Rectangle 8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1" name="Rectangle 6"/>
          <p:cNvGrpSpPr/>
          <p:nvPr/>
        </p:nvGrpSpPr>
        <p:grpSpPr>
          <a:xfrm>
            <a:off x="216000" y="228600"/>
            <a:ext cx="11747520" cy="6387840"/>
            <a:chOff x="216000" y="228600"/>
            <a:chExt cx="11747520" cy="6387840"/>
          </a:xfrm>
        </p:grpSpPr>
        <p:pic>
          <p:nvPicPr>
            <p:cNvPr id="2" name="Rectangle 6" descr=""/>
            <p:cNvPicPr/>
            <p:nvPr/>
          </p:nvPicPr>
          <p:blipFill>
            <a:blip r:embed="rId2"/>
            <a:stretch/>
          </p:blipFill>
          <p:spPr>
            <a:xfrm>
              <a:off x="216000" y="228600"/>
              <a:ext cx="11747520" cy="6384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" name=""/>
            <p:cNvSpPr/>
            <p:nvPr/>
          </p:nvSpPr>
          <p:spPr>
            <a:xfrm>
              <a:off x="235080" y="237600"/>
              <a:ext cx="11721960" cy="637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4" name="Rectangle 7"/>
          <p:cNvSpPr/>
          <p:nvPr/>
        </p:nvSpPr>
        <p:spPr>
          <a:xfrm>
            <a:off x="371520" y="374760"/>
            <a:ext cx="11449080" cy="6108480"/>
          </a:xfrm>
          <a:prstGeom prst="rect">
            <a:avLst/>
          </a:prstGeom>
          <a:noFill/>
          <a:ln cap="sq" w="648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262626"/>
                </a:solidFill>
                <a:latin typeface="Century Gothic"/>
              </a:rPr>
              <a:t>Click to edit the title text format</a:t>
            </a: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252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1" marL="45720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2" marL="73008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3" marL="100476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4" marL="127944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5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6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3"/>
          <p:cNvSpPr>
            <a:spLocks noGrp="1"/>
          </p:cNvSpPr>
          <p:nvPr>
            <p:ph type="dt" idx="1"/>
          </p:nvPr>
        </p:nvSpPr>
        <p:spPr>
          <a:xfrm>
            <a:off x="7256160" y="6035760"/>
            <a:ext cx="289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404040"/>
                </a:solidFill>
                <a:latin typeface="Gill Sans MT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055366-F292-4A7F-A7EE-51107EB794A1}" type="datetime">
              <a:rPr b="0" lang="en-US" sz="1000" spc="-1" strike="noStrike">
                <a:solidFill>
                  <a:srgbClr val="404040"/>
                </a:solidFill>
                <a:latin typeface="Gill Sans MT"/>
              </a:rPr>
              <a:t>08/29/26</a:t>
            </a:fld>
            <a:endParaRPr b="0" lang="en-US" sz="10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" name="PlaceHolder 4"/>
          <p:cNvSpPr>
            <a:spLocks noGrp="1"/>
          </p:cNvSpPr>
          <p:nvPr>
            <p:ph type="ftr" idx="2"/>
          </p:nvPr>
        </p:nvSpPr>
        <p:spPr>
          <a:xfrm>
            <a:off x="1066680" y="6035760"/>
            <a:ext cx="5816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5"/>
          <p:cNvSpPr>
            <a:spLocks noGrp="1"/>
          </p:cNvSpPr>
          <p:nvPr>
            <p:ph type="sldNum" idx="3"/>
          </p:nvPr>
        </p:nvSpPr>
        <p:spPr>
          <a:xfrm>
            <a:off x="10287000" y="6035760"/>
            <a:ext cx="8380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404040"/>
                </a:solidFill>
                <a:latin typeface="Gill Sans MT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F9C394-9765-427D-80DE-45AE748A5F72}" type="slidenum">
              <a:rPr b="0" lang="en-US" sz="1000" spc="-1" strike="noStrike">
                <a:solidFill>
                  <a:srgbClr val="404040"/>
                </a:solidFill>
                <a:latin typeface="Gill Sans MT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Rectangle 4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47" name="Rectangle 9"/>
          <p:cNvGrpSpPr/>
          <p:nvPr/>
        </p:nvGrpSpPr>
        <p:grpSpPr>
          <a:xfrm>
            <a:off x="1244520" y="1219320"/>
            <a:ext cx="9690120" cy="4406760"/>
            <a:chOff x="1244520" y="1219320"/>
            <a:chExt cx="9690120" cy="4406760"/>
          </a:xfrm>
        </p:grpSpPr>
        <p:pic>
          <p:nvPicPr>
            <p:cNvPr id="48" name="Rectangle 9" descr=""/>
            <p:cNvPicPr/>
            <p:nvPr/>
          </p:nvPicPr>
          <p:blipFill>
            <a:blip r:embed="rId2"/>
            <a:stretch/>
          </p:blipFill>
          <p:spPr>
            <a:xfrm>
              <a:off x="1244520" y="1219320"/>
              <a:ext cx="9690120" cy="4406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>
              <a:off x="1308240" y="1268280"/>
              <a:ext cx="9575640" cy="4307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50" name="Rectangle 10"/>
          <p:cNvSpPr/>
          <p:nvPr/>
        </p:nvSpPr>
        <p:spPr>
          <a:xfrm>
            <a:off x="1447920" y="1411200"/>
            <a:ext cx="9296280" cy="4035600"/>
          </a:xfrm>
          <a:prstGeom prst="rect">
            <a:avLst/>
          </a:prstGeom>
          <a:noFill/>
          <a:ln cap="sq" w="64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1" name="Rectangle 14"/>
          <p:cNvSpPr/>
          <p:nvPr/>
        </p:nvSpPr>
        <p:spPr>
          <a:xfrm>
            <a:off x="5135400" y="1268280"/>
            <a:ext cx="1920960" cy="730440"/>
          </a:xfrm>
          <a:prstGeom prst="rect">
            <a:avLst/>
          </a:prstGeom>
          <a:solidFill>
            <a:srgbClr val="78ae6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52" name="Group 6"/>
          <p:cNvGrpSpPr/>
          <p:nvPr/>
        </p:nvGrpSpPr>
        <p:grpSpPr>
          <a:xfrm>
            <a:off x="5249880" y="1268280"/>
            <a:ext cx="1692360" cy="615960"/>
            <a:chOff x="5249880" y="1268280"/>
            <a:chExt cx="1692360" cy="615960"/>
          </a:xfrm>
        </p:grpSpPr>
        <p:sp>
          <p:nvSpPr>
            <p:cNvPr id="53" name="Straight Connector 16"/>
            <p:cNvSpPr/>
            <p:nvPr/>
          </p:nvSpPr>
          <p:spPr>
            <a:xfrm>
              <a:off x="5249880" y="1268280"/>
              <a:ext cx="0" cy="61272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  <p:sp>
          <p:nvSpPr>
            <p:cNvPr id="54" name="Straight Connector 17"/>
            <p:cNvSpPr/>
            <p:nvPr/>
          </p:nvSpPr>
          <p:spPr>
            <a:xfrm>
              <a:off x="6942240" y="1268280"/>
              <a:ext cx="0" cy="61272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  <p:sp>
          <p:nvSpPr>
            <p:cNvPr id="55" name="Straight Connector 18"/>
            <p:cNvSpPr/>
            <p:nvPr/>
          </p:nvSpPr>
          <p:spPr>
            <a:xfrm>
              <a:off x="5249880" y="1884240"/>
              <a:ext cx="169236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262626"/>
                </a:solidFill>
                <a:latin typeface="Century Gothic"/>
              </a:rPr>
              <a:t>Click to edit the title text format</a:t>
            </a: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252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1" marL="45720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2" marL="73008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3" marL="100476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4" marL="127944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5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6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 type="dt" idx="4"/>
          </p:nvPr>
        </p:nvSpPr>
        <p:spPr>
          <a:xfrm>
            <a:off x="5317920" y="1341360"/>
            <a:ext cx="1555560" cy="4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ffffff"/>
                </a:solidFill>
                <a:latin typeface="Gill Sans MT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47669F-54E2-47B8-8B4B-3E3AFDD1624D}" type="datetime">
              <a:rPr b="0" lang="en-US" sz="1300" spc="-1" strike="noStrike">
                <a:solidFill>
                  <a:srgbClr val="ffffff"/>
                </a:solidFill>
                <a:latin typeface="Gill Sans MT"/>
              </a:rPr>
              <a:t>08/29/26</a:t>
            </a:fld>
            <a:endParaRPr b="0" lang="en-US" sz="13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 type="ftr" idx="5"/>
          </p:nvPr>
        </p:nvSpPr>
        <p:spPr>
          <a:xfrm>
            <a:off x="1628280" y="5176440"/>
            <a:ext cx="573084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0" name="PlaceHolder 5"/>
          <p:cNvSpPr>
            <a:spLocks noGrp="1"/>
          </p:cNvSpPr>
          <p:nvPr>
            <p:ph type="sldNum" idx="6"/>
          </p:nvPr>
        </p:nvSpPr>
        <p:spPr>
          <a:xfrm>
            <a:off x="8607600" y="5176440"/>
            <a:ext cx="195552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262626"/>
                </a:solidFill>
                <a:latin typeface="Gill Sans MT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4700DB-FDCD-4BD5-A84C-6E11D3A96B25}" type="slidenum">
              <a:rPr b="0" lang="en-US" sz="1000" spc="-1" strike="noStrike">
                <a:solidFill>
                  <a:srgbClr val="262626"/>
                </a:solidFill>
                <a:latin typeface="Gill Sans MT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Rectangle 14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98" name="Rectangle 22"/>
          <p:cNvGrpSpPr/>
          <p:nvPr/>
        </p:nvGrpSpPr>
        <p:grpSpPr>
          <a:xfrm>
            <a:off x="1244520" y="1219320"/>
            <a:ext cx="9690120" cy="4406760"/>
            <a:chOff x="1244520" y="1219320"/>
            <a:chExt cx="9690120" cy="4406760"/>
          </a:xfrm>
        </p:grpSpPr>
        <p:pic>
          <p:nvPicPr>
            <p:cNvPr id="99" name="Rectangle 22" descr=""/>
            <p:cNvPicPr/>
            <p:nvPr/>
          </p:nvPicPr>
          <p:blipFill>
            <a:blip r:embed="rId2"/>
            <a:stretch/>
          </p:blipFill>
          <p:spPr>
            <a:xfrm>
              <a:off x="1244520" y="1219320"/>
              <a:ext cx="9690120" cy="4406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0" name=""/>
            <p:cNvSpPr/>
            <p:nvPr/>
          </p:nvSpPr>
          <p:spPr>
            <a:xfrm>
              <a:off x="1308240" y="1268280"/>
              <a:ext cx="9575640" cy="4307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101" name="Rectangle 23"/>
          <p:cNvSpPr/>
          <p:nvPr/>
        </p:nvSpPr>
        <p:spPr>
          <a:xfrm>
            <a:off x="1447920" y="1411200"/>
            <a:ext cx="9296280" cy="4035600"/>
          </a:xfrm>
          <a:prstGeom prst="rect">
            <a:avLst/>
          </a:prstGeom>
          <a:noFill/>
          <a:ln cap="sq" w="64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02" name="Rectangle 29"/>
          <p:cNvSpPr/>
          <p:nvPr/>
        </p:nvSpPr>
        <p:spPr>
          <a:xfrm>
            <a:off x="5135400" y="1268280"/>
            <a:ext cx="1920960" cy="730440"/>
          </a:xfrm>
          <a:prstGeom prst="rect">
            <a:avLst/>
          </a:prstGeom>
          <a:solidFill>
            <a:srgbClr val="61b07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103" name="Group 15"/>
          <p:cNvGrpSpPr/>
          <p:nvPr/>
        </p:nvGrpSpPr>
        <p:grpSpPr>
          <a:xfrm>
            <a:off x="5249880" y="1268280"/>
            <a:ext cx="1692360" cy="615960"/>
            <a:chOff x="5249880" y="1268280"/>
            <a:chExt cx="1692360" cy="615960"/>
          </a:xfrm>
        </p:grpSpPr>
        <p:sp>
          <p:nvSpPr>
            <p:cNvPr id="104" name="Straight Connector 16"/>
            <p:cNvSpPr/>
            <p:nvPr/>
          </p:nvSpPr>
          <p:spPr>
            <a:xfrm>
              <a:off x="5249880" y="1268280"/>
              <a:ext cx="0" cy="61272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  <p:sp>
          <p:nvSpPr>
            <p:cNvPr id="105" name="Straight Connector 17"/>
            <p:cNvSpPr/>
            <p:nvPr/>
          </p:nvSpPr>
          <p:spPr>
            <a:xfrm>
              <a:off x="6942240" y="1268280"/>
              <a:ext cx="0" cy="61272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  <p:sp>
          <p:nvSpPr>
            <p:cNvPr id="106" name="Straight Connector 18"/>
            <p:cNvSpPr/>
            <p:nvPr/>
          </p:nvSpPr>
          <p:spPr>
            <a:xfrm>
              <a:off x="5249880" y="1884240"/>
              <a:ext cx="169236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262626"/>
                </a:solidFill>
                <a:latin typeface="Century Gothic"/>
              </a:rPr>
              <a:t>Click to edit the title text format</a:t>
            </a: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 type="body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252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1" marL="45720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2" marL="73008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3" marL="100476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4" marL="127944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5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6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 type="dt" idx="7"/>
          </p:nvPr>
        </p:nvSpPr>
        <p:spPr>
          <a:xfrm>
            <a:off x="5317920" y="1344240"/>
            <a:ext cx="155556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ffffff"/>
                </a:solidFill>
                <a:latin typeface="Gill Sans MT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70C52B-0FBC-4DFC-9D12-03201057F110}" type="datetime">
              <a:rPr b="0" lang="en-US" sz="1300" spc="-1" strike="noStrike">
                <a:solidFill>
                  <a:srgbClr val="ffffff"/>
                </a:solidFill>
                <a:latin typeface="Gill Sans MT"/>
              </a:rPr>
              <a:t>08/29/26</a:t>
            </a:fld>
            <a:endParaRPr b="0" lang="en-US" sz="13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10" name="PlaceHolder 4"/>
          <p:cNvSpPr>
            <a:spLocks noGrp="1"/>
          </p:cNvSpPr>
          <p:nvPr>
            <p:ph type="ftr" idx="8"/>
          </p:nvPr>
        </p:nvSpPr>
        <p:spPr>
          <a:xfrm>
            <a:off x="1628280" y="5176440"/>
            <a:ext cx="566100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11" name="PlaceHolder 5"/>
          <p:cNvSpPr>
            <a:spLocks noGrp="1"/>
          </p:cNvSpPr>
          <p:nvPr>
            <p:ph type="sldNum" idx="9"/>
          </p:nvPr>
        </p:nvSpPr>
        <p:spPr>
          <a:xfrm>
            <a:off x="8604000" y="5176440"/>
            <a:ext cx="195876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262626"/>
                </a:solidFill>
                <a:latin typeface="Gill Sans MT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61FC30-C16D-49AA-9F4E-AB6A0E4505F1}" type="slidenum">
              <a:rPr b="0" lang="en-US" sz="1000" spc="-1" strike="noStrike">
                <a:solidFill>
                  <a:srgbClr val="262626"/>
                </a:solidFill>
                <a:latin typeface="Gill Sans MT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  <p:sldLayoutId id="2147483686" r:id="rId14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Rectangle 9"/>
          <p:cNvSpPr/>
          <p:nvPr/>
        </p:nvSpPr>
        <p:spPr>
          <a:xfrm>
            <a:off x="8120160" y="237960"/>
            <a:ext cx="3825720" cy="6382080"/>
          </a:xfrm>
          <a:prstGeom prst="rect">
            <a:avLst/>
          </a:prstGeom>
          <a:solidFill>
            <a:srgbClr val="d9d9d9">
              <a:alpha val="6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9" name="Rectangle 12"/>
          <p:cNvSpPr/>
          <p:nvPr/>
        </p:nvSpPr>
        <p:spPr>
          <a:xfrm>
            <a:off x="8255160" y="374760"/>
            <a:ext cx="3555720" cy="6108480"/>
          </a:xfrm>
          <a:prstGeom prst="rect">
            <a:avLst/>
          </a:prstGeom>
          <a:noFill/>
          <a:ln cap="sq" w="64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262626"/>
                </a:solidFill>
                <a:latin typeface="Century Gothic"/>
              </a:rPr>
              <a:t>Click to edit the title text format</a:t>
            </a: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51" name="PlaceHolder 2"/>
          <p:cNvSpPr>
            <a:spLocks noGrp="1"/>
          </p:cNvSpPr>
          <p:nvPr>
            <p:ph type="body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252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1" marL="45720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2" marL="73008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3" marL="100476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4" marL="127944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5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6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52" name="PlaceHolder 3"/>
          <p:cNvSpPr>
            <a:spLocks noGrp="1"/>
          </p:cNvSpPr>
          <p:nvPr>
            <p:ph type="dt" idx="10"/>
          </p:nvPr>
        </p:nvSpPr>
        <p:spPr>
          <a:xfrm>
            <a:off x="5587560" y="6035760"/>
            <a:ext cx="1955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262626"/>
                </a:solidFill>
                <a:latin typeface="Gill Sans MT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4065BB-95D6-4843-9077-BA03D4708ED7}" type="datetime">
              <a:rPr b="0" lang="en-US" sz="1000" spc="-1" strike="noStrike">
                <a:solidFill>
                  <a:srgbClr val="262626"/>
                </a:solidFill>
                <a:latin typeface="Gill Sans MT"/>
              </a:rPr>
              <a:t>08/29/26</a:t>
            </a:fld>
            <a:endParaRPr b="0" lang="en-US" sz="10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53" name="PlaceHolder 4"/>
          <p:cNvSpPr>
            <a:spLocks noGrp="1"/>
          </p:cNvSpPr>
          <p:nvPr>
            <p:ph type="ftr" idx="11"/>
          </p:nvPr>
        </p:nvSpPr>
        <p:spPr>
          <a:xfrm>
            <a:off x="685440" y="6035760"/>
            <a:ext cx="45846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54" name="PlaceHolder 5"/>
          <p:cNvSpPr>
            <a:spLocks noGrp="1"/>
          </p:cNvSpPr>
          <p:nvPr>
            <p:ph type="sldNum" idx="12"/>
          </p:nvPr>
        </p:nvSpPr>
        <p:spPr>
          <a:xfrm>
            <a:off x="10396440" y="6035760"/>
            <a:ext cx="12240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262626"/>
                </a:solidFill>
                <a:latin typeface="Gill Sans MT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F8E3D3-76EF-466C-BE7C-B2D9F69F9AB0}" type="slidenum">
              <a:rPr b="0" lang="en-US" sz="1000" spc="-1" strike="noStrike">
                <a:solidFill>
                  <a:srgbClr val="262626"/>
                </a:solidFill>
                <a:latin typeface="Gill Sans MT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Rectangle 10"/>
          <p:cNvSpPr/>
          <p:nvPr/>
        </p:nvSpPr>
        <p:spPr>
          <a:xfrm>
            <a:off x="8120160" y="237960"/>
            <a:ext cx="3825720" cy="6382080"/>
          </a:xfrm>
          <a:prstGeom prst="rect">
            <a:avLst/>
          </a:prstGeom>
          <a:solidFill>
            <a:srgbClr val="d9d9d9">
              <a:alpha val="6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2" name="Rectangle 11"/>
          <p:cNvSpPr/>
          <p:nvPr/>
        </p:nvSpPr>
        <p:spPr>
          <a:xfrm>
            <a:off x="8255160" y="374760"/>
            <a:ext cx="3555720" cy="6108480"/>
          </a:xfrm>
          <a:prstGeom prst="rect">
            <a:avLst/>
          </a:prstGeom>
          <a:noFill/>
          <a:ln cap="sq" w="64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1066680" y="642960"/>
            <a:ext cx="100584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262626"/>
                </a:solidFill>
                <a:latin typeface="Century Gothic"/>
              </a:rPr>
              <a:t>Click to edit the title text format</a:t>
            </a: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 type="body"/>
          </p:nvPr>
        </p:nvSpPr>
        <p:spPr>
          <a:xfrm>
            <a:off x="1066680" y="2103120"/>
            <a:ext cx="10058400" cy="384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252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1" marL="45720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2" marL="73008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3" marL="100476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4" marL="1279440" indent="-182520"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5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 lvl="6" marL="1279440" indent="-182520">
              <a:spcBef>
                <a:spcPts val="901"/>
              </a:spcBef>
              <a:buClr>
                <a:srgbClr val="000000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 type="dt" idx="13"/>
          </p:nvPr>
        </p:nvSpPr>
        <p:spPr>
          <a:xfrm>
            <a:off x="5662080" y="6035760"/>
            <a:ext cx="2071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000" spc="-1" strike="noStrike">
                <a:solidFill>
                  <a:srgbClr val="ffffff"/>
                </a:solidFill>
                <a:latin typeface="Gill Sans MT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99016C-D1C0-4838-BBC6-1A26FE39A481}" type="datetime">
              <a:rPr b="1" lang="en-US" sz="1000" spc="-1" strike="noStrike">
                <a:solidFill>
                  <a:srgbClr val="ffffff"/>
                </a:solidFill>
                <a:latin typeface="Gill Sans MT"/>
              </a:rPr>
              <a:t>08/29/26</a:t>
            </a:fld>
            <a:endParaRPr b="0" lang="en-US" sz="10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 type="ftr" idx="14"/>
          </p:nvPr>
        </p:nvSpPr>
        <p:spPr>
          <a:xfrm>
            <a:off x="612720" y="6035760"/>
            <a:ext cx="4587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 type="sldNum" idx="15"/>
          </p:nvPr>
        </p:nvSpPr>
        <p:spPr>
          <a:xfrm>
            <a:off x="10396080" y="6035760"/>
            <a:ext cx="1225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404040"/>
                </a:solidFill>
                <a:latin typeface="Gill Sans MT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2F8C38-7AFA-4091-9A87-FE215BEF5C36}" type="slidenum">
              <a:rPr b="0" lang="en-US" sz="1000" spc="-1" strike="noStrike">
                <a:solidFill>
                  <a:srgbClr val="404040"/>
                </a:solidFill>
                <a:latin typeface="Gill Sans MT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10.pn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tif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6.jpe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35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36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37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38" name="PlaceHolder 1"/>
          <p:cNvSpPr>
            <a:spLocks noGrp="1"/>
          </p:cNvSpPr>
          <p:nvPr>
            <p:ph type="title"/>
          </p:nvPr>
        </p:nvSpPr>
        <p:spPr>
          <a:xfrm>
            <a:off x="925200" y="1240920"/>
            <a:ext cx="9793080" cy="1527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Century Gothic"/>
              </a:rPr>
              <a:t>A medical epopee: </a:t>
            </a:r>
            <a:br>
              <a:rPr sz="3600"/>
            </a:br>
            <a:r>
              <a:rPr b="1" lang="en-US" sz="3600" spc="-1" strike="noStrike">
                <a:solidFill>
                  <a:srgbClr val="262626"/>
                </a:solidFill>
                <a:latin typeface="Century Gothic"/>
              </a:rPr>
              <a:t>recurrent fungal endocarditis, heart transplantation and chylopericardium </a:t>
            </a:r>
            <a:br>
              <a:rPr sz="3600"/>
            </a:br>
            <a:r>
              <a:rPr b="1" lang="en-US" sz="3600" spc="-1" strike="noStrike">
                <a:solidFill>
                  <a:srgbClr val="262626"/>
                </a:solidFill>
                <a:latin typeface="Century Gothic"/>
              </a:rPr>
              <a:t>(case report)</a:t>
            </a:r>
            <a:endParaRPr b="0" lang="en-US" sz="3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39" name=""/>
          <p:cNvSpPr txBox="1"/>
          <p:nvPr/>
        </p:nvSpPr>
        <p:spPr>
          <a:xfrm>
            <a:off x="838080" y="2995200"/>
            <a:ext cx="9792000" cy="3406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Gill Sans MT"/>
              </a:rPr>
              <a:t>Authors: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 Antonio de Santis</a:t>
            </a: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1,4</a:t>
            </a:r>
            <a:r>
              <a:rPr b="0" lang="pt-BR" sz="14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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, PhD; Guilherme Moratti Gilberto</a:t>
            </a: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2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, MD; Sandrigo Mangini</a:t>
            </a: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1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, PhD; Adalberto Batalha Megale</a:t>
            </a: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2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, MD; Fabio Antonio Gaiotto</a:t>
            </a: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3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, PhD; Ricardo Mingarini Terra</a:t>
            </a: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3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, PhD; Rodrigo Gobbo Garcia</a:t>
            </a: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2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, PhD.</a:t>
            </a:r>
            <a:endParaRPr b="0" lang="en-US" sz="14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 </a:t>
            </a:r>
            <a:endParaRPr b="0" lang="en-US" sz="14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baseline="30000">
                <a:solidFill>
                  <a:srgbClr val="000000"/>
                </a:solidFill>
                <a:latin typeface="Gill Sans MT"/>
              </a:rPr>
              <a:t>1 </a:t>
            </a:r>
            <a:r>
              <a:rPr b="0" lang="en-US" sz="1400" spc="-1" strike="noStrike">
                <a:solidFill>
                  <a:srgbClr val="000000"/>
                </a:solidFill>
                <a:latin typeface="Gill Sans MT"/>
              </a:rPr>
              <a:t>Department of Cardiology, Hospital Israelita Albert Einstein, Sao Paulo, Brazil.</a:t>
            </a:r>
            <a:endParaRPr b="0" lang="en-US" sz="14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baseline="30000">
                <a:solidFill>
                  <a:srgbClr val="000000"/>
                </a:solidFill>
                <a:latin typeface="Gill Sans MT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Gill Sans MT"/>
              </a:rPr>
              <a:t>Deparment of Interventional Radiology. 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Hospital Israelita Albert Einstein, Sao Paulo, Brazil.</a:t>
            </a:r>
            <a:endParaRPr b="0" lang="en-US" sz="14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3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Department of Cardiothoracic Surgery, Hospital Israelita Albert Einstein, Sao Paulo, Brazil.</a:t>
            </a:r>
            <a:endParaRPr b="0" lang="en-US" sz="14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 baseline="30000">
                <a:solidFill>
                  <a:srgbClr val="000000"/>
                </a:solidFill>
                <a:latin typeface="Gill Sans MT"/>
              </a:rPr>
              <a:t>4</a:t>
            </a:r>
            <a:r>
              <a:rPr b="0" lang="pt-BR" sz="1400" spc="-1" strike="noStrike">
                <a:solidFill>
                  <a:srgbClr val="000000"/>
                </a:solidFill>
                <a:latin typeface="Gill Sans MT"/>
              </a:rPr>
              <a:t>Heart Institute (InCor), University of São Paulo Medical School, Dr Eneas de Carvalho Aguiar Street 44, Sao Paulo, Brazil.</a:t>
            </a:r>
            <a:endParaRPr b="0" lang="en-US" sz="14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Gill Sans MT"/>
            </a:endParaRPr>
          </a:p>
        </p:txBody>
      </p:sp>
      <p:pic>
        <p:nvPicPr>
          <p:cNvPr id="240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303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304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05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306" name="PlaceHolder 1"/>
          <p:cNvSpPr>
            <a:spLocks noGrp="1"/>
          </p:cNvSpPr>
          <p:nvPr>
            <p:ph type="title"/>
          </p:nvPr>
        </p:nvSpPr>
        <p:spPr>
          <a:xfrm>
            <a:off x="603000" y="801720"/>
            <a:ext cx="9791640" cy="15271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br>
              <a:rPr sz="1600"/>
            </a:b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TIMELINE OF EVENTS: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pic>
        <p:nvPicPr>
          <p:cNvPr id="307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  <p:pic>
        <p:nvPicPr>
          <p:cNvPr id="308" name="Imagem 14" descr=""/>
          <p:cNvPicPr/>
          <p:nvPr/>
        </p:nvPicPr>
        <p:blipFill>
          <a:blip r:embed="rId3"/>
          <a:stretch/>
        </p:blipFill>
        <p:spPr>
          <a:xfrm>
            <a:off x="995400" y="2330280"/>
            <a:ext cx="9793080" cy="346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310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311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12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603000" y="801720"/>
            <a:ext cx="9791640" cy="15271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br>
              <a:rPr sz="1600"/>
            </a:b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pic>
        <p:nvPicPr>
          <p:cNvPr id="314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  <p:sp>
        <p:nvSpPr>
          <p:cNvPr id="315" name=""/>
          <p:cNvSpPr txBox="1"/>
          <p:nvPr/>
        </p:nvSpPr>
        <p:spPr>
          <a:xfrm>
            <a:off x="425160" y="2166840"/>
            <a:ext cx="10868040" cy="38894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Gill Sans MT"/>
              </a:rPr>
              <a:t>CASE PRESENTATION: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The patient was discharged from hospital at the 3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Gill Sans MT"/>
              </a:rPr>
              <a:t>th</a:t>
            </a: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 posteoperative day.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6-months follow up: normal life, without cardiovascular symptoms. 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42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43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4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603000" y="847800"/>
            <a:ext cx="9791640" cy="15271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46" name=""/>
          <p:cNvSpPr txBox="1"/>
          <p:nvPr/>
        </p:nvSpPr>
        <p:spPr>
          <a:xfrm>
            <a:off x="603000" y="2603160"/>
            <a:ext cx="9791640" cy="3406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Gill Sans MT"/>
              </a:rPr>
              <a:t>CASE PRESENTATION: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Gill Sans MT"/>
              </a:rPr>
              <a:t>2019: A 55-year old male was </a:t>
            </a: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addmited to the cardiology unit with acute decompensated heart failure characterized by rest dyspnea,  orthopnea, fatigue, peripheral edema. 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Physical examination with signs of pulmonary and lung congestion.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pic>
        <p:nvPicPr>
          <p:cNvPr id="247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49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50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1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52" name="PlaceHolder 1"/>
          <p:cNvSpPr>
            <a:spLocks noGrp="1"/>
          </p:cNvSpPr>
          <p:nvPr>
            <p:ph type="title"/>
          </p:nvPr>
        </p:nvSpPr>
        <p:spPr>
          <a:xfrm>
            <a:off x="603000" y="473040"/>
            <a:ext cx="9791640" cy="15271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sp>
        <p:nvSpPr>
          <p:cNvPr id="253" name=""/>
          <p:cNvSpPr txBox="1"/>
          <p:nvPr/>
        </p:nvSpPr>
        <p:spPr>
          <a:xfrm>
            <a:off x="603000" y="2000160"/>
            <a:ext cx="10868040" cy="38894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5000"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Gill Sans MT"/>
              </a:rPr>
              <a:t>CASE PRESENTATION: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Gill Sans MT"/>
              </a:rPr>
              <a:t>Past medical history marked by redo cardiac valve surgeries: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2009: Mitral valve replacement using a bioprosthesis due to symptomatic anterior leaflet prolapse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2010: Mitral bioprosthesis replacement due to symptomatic paraprosthetic leak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2013: </a:t>
            </a:r>
            <a:r>
              <a:rPr b="0" i="1" lang="en-US" sz="1600" spc="-1" strike="noStrike">
                <a:solidFill>
                  <a:srgbClr val="000000"/>
                </a:solidFill>
                <a:latin typeface="Gill Sans MT"/>
              </a:rPr>
              <a:t>Candida parapsilosis </a:t>
            </a: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prosthetic endocarditis. Treatment: mitral bioprosthetic replacement associated with 6-week of intravenous liposomal amphotericin-B and 1-year of oral fluconazole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2016: </a:t>
            </a:r>
            <a:r>
              <a:rPr b="0" i="1" lang="en-US" sz="1600" spc="-1" strike="noStrike">
                <a:solidFill>
                  <a:srgbClr val="000000"/>
                </a:solidFill>
                <a:latin typeface="Gill Sans MT"/>
              </a:rPr>
              <a:t>Candida parapsilosis </a:t>
            </a: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endocarditis of the mitral bioprosthesis with native aortic valve involvement. Treatment: mitral and aortic valve replacement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Gill Sans MT"/>
              </a:rPr>
              <a:t>Systolic heart failure (Left ventricular ejection fration= 25%) after the last valve surgery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Gill Sans MT"/>
              </a:rPr>
              <a:t>Cardiac ressincronization therapy (2018)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pic>
        <p:nvPicPr>
          <p:cNvPr id="254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56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57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8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59" name="PlaceHolder 1"/>
          <p:cNvSpPr>
            <a:spLocks noGrp="1"/>
          </p:cNvSpPr>
          <p:nvPr>
            <p:ph type="title"/>
          </p:nvPr>
        </p:nvSpPr>
        <p:spPr>
          <a:xfrm>
            <a:off x="603000" y="522360"/>
            <a:ext cx="9791640" cy="15271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pic>
        <p:nvPicPr>
          <p:cNvPr id="260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  <p:pic>
        <p:nvPicPr>
          <p:cNvPr id="261" name="Imagem 8" descr=""/>
          <p:cNvPicPr/>
          <p:nvPr/>
        </p:nvPicPr>
        <p:blipFill>
          <a:blip r:embed="rId3"/>
          <a:stretch/>
        </p:blipFill>
        <p:spPr>
          <a:xfrm>
            <a:off x="896760" y="2082960"/>
            <a:ext cx="8940960" cy="3314520"/>
          </a:xfrm>
          <a:prstGeom prst="rect">
            <a:avLst/>
          </a:prstGeom>
          <a:ln w="0">
            <a:noFill/>
          </a:ln>
        </p:spPr>
      </p:pic>
      <p:sp>
        <p:nvSpPr>
          <p:cNvPr id="262" name=""/>
          <p:cNvSpPr txBox="1"/>
          <p:nvPr/>
        </p:nvSpPr>
        <p:spPr>
          <a:xfrm>
            <a:off x="838080" y="5467320"/>
            <a:ext cx="9792000" cy="311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33000"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Gill Sans MT"/>
              </a:rPr>
              <a:t>Figure 1. Echocardiographic images of the fungal endocarditis.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Gill Sans MT"/>
              </a:rPr>
              <a:t>Panel A:</a:t>
            </a: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 A large fungal vegetation on mitral prosthesis (yellow arrow). </a:t>
            </a:r>
            <a:r>
              <a:rPr b="1" lang="en-US" sz="1800" spc="-1" strike="noStrike">
                <a:solidFill>
                  <a:srgbClr val="000000"/>
                </a:solidFill>
                <a:latin typeface="Gill Sans MT"/>
              </a:rPr>
              <a:t>Panel B</a:t>
            </a: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: Aortic prosthesis vegetations (yellow arrow).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64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65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6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603000" y="563040"/>
            <a:ext cx="9791640" cy="1527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pic>
        <p:nvPicPr>
          <p:cNvPr id="268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  <p:sp>
        <p:nvSpPr>
          <p:cNvPr id="269" name=""/>
          <p:cNvSpPr txBox="1"/>
          <p:nvPr/>
        </p:nvSpPr>
        <p:spPr>
          <a:xfrm>
            <a:off x="838080" y="5467320"/>
            <a:ext cx="9792000" cy="311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63000"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Gill Sans MT"/>
              </a:rPr>
              <a:t>Figure 2. </a:t>
            </a: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Histopathology of excised mitral bioprosthesis. Grocott’s methenamine silver stain showing fungal hyphae and yeasts (red arrows).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pic>
        <p:nvPicPr>
          <p:cNvPr id="270" name="Imagem 3" descr=""/>
          <p:cNvPicPr/>
          <p:nvPr/>
        </p:nvPicPr>
        <p:blipFill>
          <a:blip r:embed="rId3"/>
          <a:stretch/>
        </p:blipFill>
        <p:spPr>
          <a:xfrm>
            <a:off x="2647800" y="1760400"/>
            <a:ext cx="5407200" cy="3706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72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73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4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603000" y="563040"/>
            <a:ext cx="9791640" cy="1527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pic>
        <p:nvPicPr>
          <p:cNvPr id="276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  <p:sp>
        <p:nvSpPr>
          <p:cNvPr id="277" name=""/>
          <p:cNvSpPr txBox="1"/>
          <p:nvPr/>
        </p:nvSpPr>
        <p:spPr>
          <a:xfrm>
            <a:off x="661680" y="2090520"/>
            <a:ext cx="10868040" cy="3889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600" spc="-1" strike="noStrike">
                <a:solidFill>
                  <a:srgbClr val="000000"/>
                </a:solidFill>
                <a:latin typeface="Gill Sans MT"/>
              </a:rPr>
              <a:t>CASE PRESENTATION: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The patient presented inotrope dependence during hospitalization. Heart team evaluation was favorable to heart transplantation waiting list inclusion. 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After a 3-months period of waiting, the patient was submitted to heart transplantation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Postoperative immediate complications: acute and intermittent kidney injury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At the 10</a:t>
            </a:r>
            <a:r>
              <a:rPr b="0" lang="en-US" sz="1600" spc="-1" strike="noStrike" baseline="30000">
                <a:solidFill>
                  <a:srgbClr val="000000"/>
                </a:solidFill>
                <a:latin typeface="Gill Sans MT"/>
              </a:rPr>
              <a:t>th</a:t>
            </a: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 to 12</a:t>
            </a:r>
            <a:r>
              <a:rPr b="0" lang="en-US" sz="1600" spc="-1" strike="noStrike" baseline="30000">
                <a:solidFill>
                  <a:srgbClr val="000000"/>
                </a:solidFill>
                <a:latin typeface="Gill Sans MT"/>
              </a:rPr>
              <a:t>th</a:t>
            </a: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 postoperative days: chylopericardium diagnosis confirmed by invasive lymphangiography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Gill Sans MT"/>
              </a:rPr>
              <a:t>Percutaneous thoracic duct embolization was indicated after multidisciplinary evaluation.</a:t>
            </a: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79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80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1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82" name="PlaceHolder 1"/>
          <p:cNvSpPr>
            <a:spLocks noGrp="1"/>
          </p:cNvSpPr>
          <p:nvPr>
            <p:ph type="title"/>
          </p:nvPr>
        </p:nvSpPr>
        <p:spPr>
          <a:xfrm>
            <a:off x="603000" y="563040"/>
            <a:ext cx="9791640" cy="1527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pic>
        <p:nvPicPr>
          <p:cNvPr id="283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  <p:pic>
        <p:nvPicPr>
          <p:cNvPr id="284" name="Imagem 6" descr=""/>
          <p:cNvPicPr/>
          <p:nvPr/>
        </p:nvPicPr>
        <p:blipFill>
          <a:blip r:embed="rId3"/>
          <a:stretch/>
        </p:blipFill>
        <p:spPr>
          <a:xfrm>
            <a:off x="798480" y="1779480"/>
            <a:ext cx="3898800" cy="4515120"/>
          </a:xfrm>
          <a:prstGeom prst="rect">
            <a:avLst/>
          </a:prstGeom>
          <a:ln w="0">
            <a:noFill/>
          </a:ln>
        </p:spPr>
      </p:pic>
      <p:sp>
        <p:nvSpPr>
          <p:cNvPr id="285" name=""/>
          <p:cNvSpPr txBox="1"/>
          <p:nvPr/>
        </p:nvSpPr>
        <p:spPr>
          <a:xfrm>
            <a:off x="5285880" y="2931840"/>
            <a:ext cx="3095640" cy="1834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Gill Sans MT"/>
              </a:rPr>
              <a:t>Figure 3. Panel A: </a:t>
            </a: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Retrograde thoracic duct catheterization (yellow arrow) with lipiodol leakage into the pericardic sac. 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87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88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9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90" name="PlaceHolder 1"/>
          <p:cNvSpPr>
            <a:spLocks noGrp="1"/>
          </p:cNvSpPr>
          <p:nvPr>
            <p:ph type="title"/>
          </p:nvPr>
        </p:nvSpPr>
        <p:spPr>
          <a:xfrm>
            <a:off x="603000" y="563040"/>
            <a:ext cx="9791640" cy="1527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pic>
        <p:nvPicPr>
          <p:cNvPr id="291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  <p:sp>
        <p:nvSpPr>
          <p:cNvPr id="292" name=""/>
          <p:cNvSpPr txBox="1"/>
          <p:nvPr/>
        </p:nvSpPr>
        <p:spPr>
          <a:xfrm>
            <a:off x="4411800" y="3125520"/>
            <a:ext cx="4365360" cy="3284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Gill Sans MT"/>
              </a:rPr>
              <a:t>Figure 3. Panel B: </a:t>
            </a: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Transhepatic cisterna chyli puncture. Note the lipiodol into the thoracic duct (yellow arrows) and the lymphopericardial fistula (red arrow).</a:t>
            </a:r>
            <a:r>
              <a:rPr b="0" lang="pt-BR" sz="1800" spc="-1" strike="noStrike">
                <a:solidFill>
                  <a:srgbClr val="000000"/>
                </a:solidFill>
                <a:latin typeface="Gill Sans MT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pic>
        <p:nvPicPr>
          <p:cNvPr id="293" name="Imagem 3" descr=""/>
          <p:cNvPicPr/>
          <p:nvPr/>
        </p:nvPicPr>
        <p:blipFill>
          <a:blip r:embed="rId3"/>
          <a:stretch/>
        </p:blipFill>
        <p:spPr>
          <a:xfrm>
            <a:off x="669960" y="2006640"/>
            <a:ext cx="3532320" cy="4097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Rectangle 7"/>
          <p:cNvSpPr/>
          <p:nvPr/>
        </p:nvSpPr>
        <p:spPr>
          <a:xfrm>
            <a:off x="0" y="0"/>
            <a:ext cx="12192120" cy="685800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grpSp>
        <p:nvGrpSpPr>
          <p:cNvPr id="295" name="Rectangle 9"/>
          <p:cNvGrpSpPr/>
          <p:nvPr/>
        </p:nvGrpSpPr>
        <p:grpSpPr>
          <a:xfrm>
            <a:off x="203040" y="216000"/>
            <a:ext cx="11734920" cy="6387480"/>
            <a:chOff x="203040" y="216000"/>
            <a:chExt cx="11734920" cy="6387480"/>
          </a:xfrm>
        </p:grpSpPr>
        <p:pic>
          <p:nvPicPr>
            <p:cNvPr id="296" name="Rectangle 9" descr=""/>
            <p:cNvPicPr/>
            <p:nvPr/>
          </p:nvPicPr>
          <p:blipFill>
            <a:blip r:embed="rId1"/>
            <a:stretch/>
          </p:blipFill>
          <p:spPr>
            <a:xfrm>
              <a:off x="203040" y="216000"/>
              <a:ext cx="11734920" cy="63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97" name=""/>
            <p:cNvSpPr/>
            <p:nvPr/>
          </p:nvSpPr>
          <p:spPr>
            <a:xfrm>
              <a:off x="209520" y="226800"/>
              <a:ext cx="11723760" cy="637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Gill Sans MT"/>
              </a:endParaRPr>
            </a:p>
          </p:txBody>
        </p:sp>
      </p:grpSp>
      <p:sp>
        <p:nvSpPr>
          <p:cNvPr id="298" name="PlaceHolder 1"/>
          <p:cNvSpPr>
            <a:spLocks noGrp="1"/>
          </p:cNvSpPr>
          <p:nvPr>
            <p:ph type="title"/>
          </p:nvPr>
        </p:nvSpPr>
        <p:spPr>
          <a:xfrm>
            <a:off x="603000" y="563040"/>
            <a:ext cx="9791640" cy="1527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A medical epopee: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recurrent fungal endocarditis, heart transplantation and chylopericardium 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Century Gothic"/>
              </a:rPr>
              <a:t>(case report)</a:t>
            </a:r>
            <a:endParaRPr b="0" lang="en-US" sz="1600" spc="-1" strike="noStrike">
              <a:solidFill>
                <a:srgbClr val="262626"/>
              </a:solidFill>
              <a:latin typeface="Century Gothic"/>
            </a:endParaRPr>
          </a:p>
        </p:txBody>
      </p:sp>
      <p:pic>
        <p:nvPicPr>
          <p:cNvPr id="299" name="Imagem 4" descr=""/>
          <p:cNvPicPr/>
          <p:nvPr/>
        </p:nvPicPr>
        <p:blipFill>
          <a:blip r:embed="rId2"/>
          <a:stretch/>
        </p:blipFill>
        <p:spPr>
          <a:xfrm>
            <a:off x="425520" y="311040"/>
            <a:ext cx="5308560" cy="559080"/>
          </a:xfrm>
          <a:prstGeom prst="rect">
            <a:avLst/>
          </a:prstGeom>
          <a:ln w="0">
            <a:noFill/>
          </a:ln>
        </p:spPr>
      </p:pic>
      <p:sp>
        <p:nvSpPr>
          <p:cNvPr id="300" name=""/>
          <p:cNvSpPr txBox="1"/>
          <p:nvPr/>
        </p:nvSpPr>
        <p:spPr>
          <a:xfrm>
            <a:off x="4411800" y="3125880"/>
            <a:ext cx="4365360" cy="1123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Gill Sans MT"/>
              </a:rPr>
              <a:t>Figure 3. Panel C: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Gill Sans MT"/>
              </a:rPr>
              <a:t>Embolized thoracic duct with micro coils (yellow arrows).</a:t>
            </a: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  <a:p>
            <a:pPr>
              <a:spcBef>
                <a:spcPts val="901"/>
              </a:spcBef>
              <a:buClr>
                <a:srgbClr val="262626"/>
              </a:buClr>
              <a:buFont typeface="Garamond"/>
              <a:buChar char="◦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Gill Sans MT"/>
            </a:endParaRPr>
          </a:p>
        </p:txBody>
      </p:sp>
      <p:pic>
        <p:nvPicPr>
          <p:cNvPr id="301" name="Imagem 5" descr=""/>
          <p:cNvPicPr/>
          <p:nvPr/>
        </p:nvPicPr>
        <p:blipFill>
          <a:blip r:embed="rId3"/>
          <a:stretch/>
        </p:blipFill>
        <p:spPr>
          <a:xfrm>
            <a:off x="458640" y="1789200"/>
            <a:ext cx="3946680" cy="4514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08T23:41:24Z</dcterms:created>
  <dc:creator>davidtitinger@gmail.com</dc:creator>
  <dc:description/>
  <dc:language>en-US</dc:language>
  <cp:lastModifiedBy>ANTONIO SERGIO LOPES</cp:lastModifiedBy>
  <dcterms:modified xsi:type="dcterms:W3CDTF">2020-10-20T00:39:28Z</dcterms:modified>
  <cp:revision>41</cp:revision>
  <dc:subject/>
  <dc:title>Apresentação do PowerPoint</dc:title>
</cp:coreProperties>
</file>